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FFF58B-A6C4-4353-8F77-4D65CEF36B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EDD8DF-2331-4481-AA8E-96C0FAB41A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5E8546-978D-47C4-B1DD-C7723F8E68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51E7F5-5435-4C63-88F3-1B0748649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EA802D-B41C-4953-87A7-7036F180B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464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4B611F-B7B7-47EA-B92E-F476FDC0A4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A58DD0-EB97-4DE2-893E-3CF6916828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031FDC-55D4-4746-877F-DD5708291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F6DE12-8EAB-44E3-A606-FFEB978CA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2BE0E4-9FFB-4C37-B5B6-E60D2D77D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158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87D5B4-4569-47F1-A918-7CBA41241A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97E84E-619F-4181-9E53-974D0803F4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A9BF79-C0EC-4298-8968-6A4DFC7B0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E907FE-41A0-4F42-9753-9976804F0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5B13AA-8354-4865-9937-8B473E092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280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B0BE54-E1B3-404D-A5AD-3D6A748CC8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E79C16-5272-436C-B235-F8F7DEC7DF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6D76A1-6420-4889-B398-251BCC539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F77597-6E94-4860-833A-7C52969702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E17A0F-3772-4AC4-AFD0-ADB8717A1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259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22C7AD-4B70-4DCA-BE58-2EDEFA6B4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390E4F-98F6-4C41-B122-5C9FA2943F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30AC44-0A23-4FAA-8C3E-7E93A4897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31DAD4-D633-40CC-8049-A82717214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332795-F977-4A9A-A36F-4C8446C6F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276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DF9F0-B1EC-4469-BDD3-16ED45814B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78F66F-1659-4A7B-B376-174B2670F8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198E4B-5AB1-4B9F-8F43-510EADF8C5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589AB2-71D7-43B5-82C8-9FDA2A5EB5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457CE9-9FC3-433E-B28D-D5DCCC648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0E3351-F34E-4084-88AB-51935119F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393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846BE0-C0B3-4E3D-A05D-635693259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D66FC9-6EDD-4091-AF16-F7B39E64D2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A24BB8-F947-4E0D-834B-6EDAEB4E2D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3046F4-1338-416F-8A28-E6A23CA802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0E7740A-5C86-482E-846D-DC25809C7D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71D91D-12EB-4C29-A383-A906ABA3D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90F5DD9-CE7C-475D-A22C-35D26EA0B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096AED9-6834-4A08-82ED-99C4AF5CC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072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FEB197-8FC5-457F-85F9-B8C2529B4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452175E-EC1E-4BD6-8748-3A2236556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70B25B-A627-4185-8EDD-67020759D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9C105B-2C92-4B4E-B5CD-E86859808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545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D4A9355-60FA-4810-8E76-CBB22F95D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C84160E-21AD-4302-9990-335214126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F1786A-16A4-4F9B-B306-4EB2352ED4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69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F4BA95-F3A3-411B-890E-F46C962FD5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89ABFC-A1C9-4C5F-AE6F-6BC3809334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AB76C7-C43D-4E9F-8339-8CCA769D60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874763-A181-449D-BF92-EB3126D2B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4557FD-5435-4777-9A26-4A87DFA48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B1D661-5B4D-4E85-B244-BB1843DBB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002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A82F2-EBFC-43D5-AE0C-53DCA25C5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D92FD6-979F-40CC-BDA6-4D2060CF1E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EA7F5F-A8EC-4D6E-BE73-DFB0735C81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3AE8A3-068E-4229-A495-8124B846A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FA4B2B-4CB5-4CCC-ADB2-90E94310B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39D09F-9A46-4E17-9CD2-80DBCF270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216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0FDD91-6E98-4A42-A311-8742051F69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0E43AD-1108-44B8-883D-C3C622A796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8B9751-D5F8-4203-8BCE-F5A3DFEFCE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04878-5D39-46BF-9848-CD32A05AE102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85492-AAAF-4832-8F53-0A9B6A216D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303032-6585-4328-8A68-02ABF7412C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319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5FE683-611E-43AF-BDA5-05421E5B9C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06314"/>
            <a:ext cx="10515600" cy="6010080"/>
          </a:xfrm>
        </p:spPr>
        <p:txBody>
          <a:bodyPr>
            <a:norm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Title: 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Effects of Mechanical Abrasion Challenge on Sound and Demineralized Dentin Surfaces treated with SDF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Author list: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Mahmoud Sayed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 a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*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,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Yuka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Tsuda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a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,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Khairul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Matin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a,b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, Ahmed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Abdou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a,c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,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Kim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Martin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d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,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Michael F.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Burrow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e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,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Junji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Tagami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a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 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a 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Department of Cariology and Operative Dentistry, Graduate School of Medical and Dental Sciences, Tokyo Medical and Dental University (TMDU), Tokyo, Japan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b 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Endowed Department of International Oral Health Science, Tsurumi University, Kanagawa, Japan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c 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Biomaterials Department, Faculty of Oral and Dental Medicine, Modern University for Technology and Information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Mokatam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, Cairo, Egypt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d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 Department of Operative Dentistry and Periodontology, University Hospital, LMU Munich, Germany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>
              <a:lnSpc>
                <a:spcPct val="106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e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aculty of Dentistry, University of Hong Kong, Hong Kong SAR, China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: Supplemental figure S1.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hart showing the delta E values for demineralized dentin treated with different tested materials at different time intervals before and after brushing procedures. Different letter indicates significant differenc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7208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a device&#10;&#10;Description automatically generated">
            <a:extLst>
              <a:ext uri="{FF2B5EF4-FFF2-40B4-BE49-F238E27FC236}">
                <a16:creationId xmlns:a16="http://schemas.microsoft.com/office/drawing/2014/main" id="{77A92406-7341-40D6-930A-43D9C1C803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467" y="1302512"/>
            <a:ext cx="10905066" cy="4252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64447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82</Words>
  <Application>Microsoft Office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moud Macklad</dc:creator>
  <cp:lastModifiedBy>Mahmoud Macklad</cp:lastModifiedBy>
  <cp:revision>2</cp:revision>
  <dcterms:created xsi:type="dcterms:W3CDTF">2020-09-12T02:53:40Z</dcterms:created>
  <dcterms:modified xsi:type="dcterms:W3CDTF">2020-10-26T08:24:29Z</dcterms:modified>
</cp:coreProperties>
</file>